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68E8C-A0D0-4D73-AC40-63A1A95B29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2FCDB3-7096-48C9-B40F-87812604CF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8EB87-6343-4486-B102-4D8E6BF1E9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B1A0D-20D1-4E4E-9770-8792F331A9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04AF8-F95F-45D0-8630-E5C31E50C9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39F1B-DF2A-4251-89BD-FE8D63721F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9E8FB-A240-4863-822C-1AD5DC258A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82719B-5C4D-4921-98A8-EF04DB3D94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66AC7-9627-4613-8F0A-2648C0C468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F67FEC-4025-4F5C-AF0A-A1312D43D9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171426-7CAD-4D68-911F-687C93EBB5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702F5-4765-436A-80E8-976BE3D70F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CA0F8B-BAC8-46B2-BC02-E42EC15B57A4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群組 7"/>
          <p:cNvGrpSpPr/>
          <p:nvPr/>
        </p:nvGrpSpPr>
        <p:grpSpPr>
          <a:xfrm>
            <a:off x="1701720" y="2138400"/>
            <a:ext cx="1636200" cy="1349280"/>
            <a:chOff x="1701720" y="2138400"/>
            <a:chExt cx="1636200" cy="1349280"/>
          </a:xfrm>
        </p:grpSpPr>
        <p:pic>
          <p:nvPicPr>
            <p:cNvPr id="42" name="Picture 3" descr="H:\20170505-IFN antibody blocks stat1 and isg15-tubulin.tif"/>
            <p:cNvPicPr/>
            <p:nvPr/>
          </p:nvPicPr>
          <p:blipFill>
            <a:blip r:embed="rId1"/>
            <a:srcRect l="11166" t="0" r="2531" b="0"/>
            <a:stretch/>
          </p:blipFill>
          <p:spPr>
            <a:xfrm>
              <a:off x="1707120" y="3308040"/>
              <a:ext cx="791640" cy="17964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43" name="Picture 4" descr="H:\20170505-IFN antibody blocks stat1 and isg15-usg15.tif"/>
            <p:cNvPicPr/>
            <p:nvPr/>
          </p:nvPicPr>
          <p:blipFill>
            <a:blip r:embed="rId2"/>
            <a:srcRect l="8084" t="0" r="3307" b="14678"/>
            <a:stretch/>
          </p:blipFill>
          <p:spPr>
            <a:xfrm>
              <a:off x="1707120" y="3061440"/>
              <a:ext cx="791640" cy="17964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44" name="Picture 5" descr="H:\20170505-IFN antibody blocks stat1 and isg15-vimentin.tif"/>
            <p:cNvPicPr/>
            <p:nvPr/>
          </p:nvPicPr>
          <p:blipFill>
            <a:blip r:embed="rId3"/>
            <a:srcRect l="8084" t="9588" r="3307" b="12221"/>
            <a:stretch/>
          </p:blipFill>
          <p:spPr>
            <a:xfrm>
              <a:off x="1707120" y="2814840"/>
              <a:ext cx="791640" cy="17964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pic>
          <p:nvPicPr>
            <p:cNvPr id="45" name="Picture 6" descr="H:\20170505-IFN antibody blocks stat1 and isg15-stat1-p-2.tif"/>
            <p:cNvPicPr/>
            <p:nvPr/>
          </p:nvPicPr>
          <p:blipFill>
            <a:blip r:embed="rId4"/>
            <a:srcRect l="5735" t="0" r="484" b="0"/>
            <a:stretch/>
          </p:blipFill>
          <p:spPr>
            <a:xfrm>
              <a:off x="1707120" y="2568240"/>
              <a:ext cx="791640" cy="17964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46" name="Text Box 14"/>
            <p:cNvSpPr/>
            <p:nvPr/>
          </p:nvSpPr>
          <p:spPr>
            <a:xfrm>
              <a:off x="2469240" y="3263760"/>
              <a:ext cx="72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ubul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文字方塊 131"/>
            <p:cNvSpPr/>
            <p:nvPr/>
          </p:nvSpPr>
          <p:spPr>
            <a:xfrm>
              <a:off x="2469240" y="2544480"/>
              <a:ext cx="867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Stat1-Y70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 Box 14"/>
            <p:cNvSpPr/>
            <p:nvPr/>
          </p:nvSpPr>
          <p:spPr>
            <a:xfrm>
              <a:off x="2469240" y="3024000"/>
              <a:ext cx="72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ISG1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矩形 1"/>
            <p:cNvSpPr/>
            <p:nvPr/>
          </p:nvSpPr>
          <p:spPr>
            <a:xfrm>
              <a:off x="2469960" y="2138400"/>
              <a:ext cx="41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IFN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 Box 14"/>
            <p:cNvSpPr/>
            <p:nvPr/>
          </p:nvSpPr>
          <p:spPr>
            <a:xfrm>
              <a:off x="2469240" y="2784240"/>
              <a:ext cx="72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Vimen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文字方塊 27"/>
            <p:cNvSpPr/>
            <p:nvPr/>
          </p:nvSpPr>
          <p:spPr>
            <a:xfrm>
              <a:off x="2040840" y="2354760"/>
              <a:ext cx="345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矩形 2"/>
            <p:cNvSpPr/>
            <p:nvPr/>
          </p:nvSpPr>
          <p:spPr>
            <a:xfrm>
              <a:off x="2482200" y="2328120"/>
              <a:ext cx="855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Anti-IFN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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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文字方塊 59"/>
            <p:cNvSpPr/>
            <p:nvPr/>
          </p:nvSpPr>
          <p:spPr>
            <a:xfrm>
              <a:off x="1897920" y="215784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直線接點 15"/>
            <p:cNvSpPr/>
            <p:nvPr/>
          </p:nvSpPr>
          <p:spPr>
            <a:xfrm>
              <a:off x="1800000" y="229716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文字方塊 59"/>
            <p:cNvSpPr/>
            <p:nvPr/>
          </p:nvSpPr>
          <p:spPr>
            <a:xfrm>
              <a:off x="2064240" y="215784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文字方塊 59"/>
            <p:cNvSpPr/>
            <p:nvPr/>
          </p:nvSpPr>
          <p:spPr>
            <a:xfrm>
              <a:off x="2229840" y="215784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文字方塊 20"/>
            <p:cNvSpPr/>
            <p:nvPr/>
          </p:nvSpPr>
          <p:spPr>
            <a:xfrm>
              <a:off x="1877400" y="2354760"/>
              <a:ext cx="183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文字方塊 20"/>
            <p:cNvSpPr/>
            <p:nvPr/>
          </p:nvSpPr>
          <p:spPr>
            <a:xfrm>
              <a:off x="1701720" y="2354760"/>
              <a:ext cx="182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文字方塊 41"/>
            <p:cNvSpPr/>
            <p:nvPr/>
          </p:nvSpPr>
          <p:spPr>
            <a:xfrm>
              <a:off x="2240280" y="2354760"/>
              <a:ext cx="223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0" name="群組 1"/>
          <p:cNvGrpSpPr/>
          <p:nvPr/>
        </p:nvGrpSpPr>
        <p:grpSpPr>
          <a:xfrm>
            <a:off x="3648240" y="2443320"/>
            <a:ext cx="1813680" cy="1049040"/>
            <a:chOff x="3648240" y="2443320"/>
            <a:chExt cx="1813680" cy="1049040"/>
          </a:xfrm>
        </p:grpSpPr>
        <p:pic>
          <p:nvPicPr>
            <p:cNvPr id="61" name="Picture 2" descr="H:\20170503-IFNA induced hif1a could be blocked by IFN antibody-hif1a.tif"/>
            <p:cNvPicPr/>
            <p:nvPr/>
          </p:nvPicPr>
          <p:blipFill>
            <a:blip r:embed="rId5"/>
            <a:srcRect l="13083" t="7670" r="5925" b="20597"/>
            <a:stretch/>
          </p:blipFill>
          <p:spPr>
            <a:xfrm>
              <a:off x="3666600" y="2835720"/>
              <a:ext cx="972000" cy="1800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62" name="Picture 5" descr="H:\20170503-IFNA induced hif1a could be blocked by IFN antibody-tubulin-2.tif"/>
            <p:cNvPicPr/>
            <p:nvPr/>
          </p:nvPicPr>
          <p:blipFill>
            <a:blip r:embed="rId6"/>
            <a:srcRect l="4796" t="14173" r="1932" b="7244"/>
            <a:stretch/>
          </p:blipFill>
          <p:spPr>
            <a:xfrm>
              <a:off x="3666600" y="3312360"/>
              <a:ext cx="972000" cy="1800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63" name="文字方塊 131"/>
            <p:cNvSpPr/>
            <p:nvPr/>
          </p:nvSpPr>
          <p:spPr>
            <a:xfrm>
              <a:off x="4641840" y="2805480"/>
              <a:ext cx="690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HIF-1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 Box 14"/>
            <p:cNvSpPr/>
            <p:nvPr/>
          </p:nvSpPr>
          <p:spPr>
            <a:xfrm>
              <a:off x="4638960" y="3246120"/>
              <a:ext cx="72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Tubul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文字方塊 21"/>
            <p:cNvSpPr/>
            <p:nvPr/>
          </p:nvSpPr>
          <p:spPr>
            <a:xfrm>
              <a:off x="4160880" y="2629080"/>
              <a:ext cx="31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2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文字方塊 27"/>
            <p:cNvSpPr/>
            <p:nvPr/>
          </p:nvSpPr>
          <p:spPr>
            <a:xfrm>
              <a:off x="4008960" y="2628360"/>
              <a:ext cx="223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矩形 2"/>
            <p:cNvSpPr/>
            <p:nvPr/>
          </p:nvSpPr>
          <p:spPr>
            <a:xfrm>
              <a:off x="4606200" y="2612520"/>
              <a:ext cx="855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Anti-IFN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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g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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文字方塊 20"/>
            <p:cNvSpPr/>
            <p:nvPr/>
          </p:nvSpPr>
          <p:spPr>
            <a:xfrm>
              <a:off x="3832560" y="2628360"/>
              <a:ext cx="183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文字方塊 20"/>
            <p:cNvSpPr/>
            <p:nvPr/>
          </p:nvSpPr>
          <p:spPr>
            <a:xfrm>
              <a:off x="3648240" y="2628360"/>
              <a:ext cx="182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矩形 1"/>
            <p:cNvSpPr/>
            <p:nvPr/>
          </p:nvSpPr>
          <p:spPr>
            <a:xfrm>
              <a:off x="4622040" y="2448720"/>
              <a:ext cx="41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IFN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文字方塊 59"/>
            <p:cNvSpPr/>
            <p:nvPr/>
          </p:nvSpPr>
          <p:spPr>
            <a:xfrm>
              <a:off x="3836880" y="244332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直線接點 33"/>
            <p:cNvSpPr/>
            <p:nvPr/>
          </p:nvSpPr>
          <p:spPr>
            <a:xfrm>
              <a:off x="3738600" y="258300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文字方塊 59"/>
            <p:cNvSpPr/>
            <p:nvPr/>
          </p:nvSpPr>
          <p:spPr>
            <a:xfrm>
              <a:off x="4002840" y="244332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文字方塊 59"/>
            <p:cNvSpPr/>
            <p:nvPr/>
          </p:nvSpPr>
          <p:spPr>
            <a:xfrm>
              <a:off x="4168800" y="244332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文字方塊 59"/>
            <p:cNvSpPr/>
            <p:nvPr/>
          </p:nvSpPr>
          <p:spPr>
            <a:xfrm>
              <a:off x="4391640" y="244332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文字方塊 21"/>
            <p:cNvSpPr/>
            <p:nvPr/>
          </p:nvSpPr>
          <p:spPr>
            <a:xfrm>
              <a:off x="4419000" y="2629080"/>
              <a:ext cx="31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 Box 14"/>
            <p:cNvSpPr/>
            <p:nvPr/>
          </p:nvSpPr>
          <p:spPr>
            <a:xfrm>
              <a:off x="4638960" y="3024360"/>
              <a:ext cx="72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Bmi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8" name="Picture 6" descr="H:\20170503-IFNA induced hif1a could be blocked by IFN antibody-bmi1-2.tif"/>
            <p:cNvPicPr/>
            <p:nvPr/>
          </p:nvPicPr>
          <p:blipFill>
            <a:blip r:embed="rId7"/>
            <a:srcRect l="7601" t="23215" r="4459" b="8098"/>
            <a:stretch/>
          </p:blipFill>
          <p:spPr>
            <a:xfrm>
              <a:off x="3666600" y="3070440"/>
              <a:ext cx="972000" cy="1800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</p:grpSp>
      <p:sp>
        <p:nvSpPr>
          <p:cNvPr id="79" name="文字方塊 2"/>
          <p:cNvSpPr/>
          <p:nvPr/>
        </p:nvSpPr>
        <p:spPr>
          <a:xfrm>
            <a:off x="4941720" y="7920"/>
            <a:ext cx="191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eh_Supplementary Fig. S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文字方塊 36"/>
          <p:cNvSpPr/>
          <p:nvPr/>
        </p:nvSpPr>
        <p:spPr>
          <a:xfrm>
            <a:off x="1308240" y="1919160"/>
            <a:ext cx="32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文字方塊 36"/>
          <p:cNvSpPr/>
          <p:nvPr/>
        </p:nvSpPr>
        <p:spPr>
          <a:xfrm>
            <a:off x="3573360" y="2124000"/>
            <a:ext cx="32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8T07:00:22Z</dcterms:created>
  <dc:creator>yeh</dc:creator>
  <dc:description/>
  <dc:language>en-US</dc:language>
  <cp:lastModifiedBy>Abella, Jerard Dave</cp:lastModifiedBy>
  <dcterms:modified xsi:type="dcterms:W3CDTF">2018-03-13T10:52:25Z</dcterms:modified>
  <cp:revision>24</cp:revision>
  <dc:subject/>
  <dc:title>PowerPoint 簡報</dc:title>
</cp:coreProperties>
</file>